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35600" cy="9867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-360"/>
            <a:ext cx="291924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14560" y="-360"/>
            <a:ext cx="291924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087280" y="739440"/>
            <a:ext cx="2560680" cy="37004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2840" y="4686120"/>
            <a:ext cx="5389560" cy="443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9370800"/>
            <a:ext cx="291924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14560" y="9370800"/>
            <a:ext cx="291924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2FA1C2-E723-4DFF-AD47-71C6A55A910D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sldImg"/>
          </p:nvPr>
        </p:nvSpPr>
        <p:spPr>
          <a:xfrm>
            <a:off x="2087640" y="739800"/>
            <a:ext cx="2560680" cy="3700440"/>
          </a:xfrm>
          <a:prstGeom prst="rect">
            <a:avLst/>
          </a:prstGeom>
          <a:ln w="0">
            <a:noFill/>
          </a:ln>
        </p:spPr>
      </p:sp>
      <p:sp>
        <p:nvSpPr>
          <p:cNvPr id="71" name="PlaceHolder 2"/>
          <p:cNvSpPr>
            <a:spLocks noGrp="1"/>
          </p:cNvSpPr>
          <p:nvPr>
            <p:ph type="body"/>
          </p:nvPr>
        </p:nvSpPr>
        <p:spPr>
          <a:xfrm>
            <a:off x="672840" y="4686120"/>
            <a:ext cx="5389560" cy="44398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igureS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スライド番号プレースホルダ 3"/>
          <p:cNvSpPr/>
          <p:nvPr/>
        </p:nvSpPr>
        <p:spPr>
          <a:xfrm>
            <a:off x="3814920" y="9371160"/>
            <a:ext cx="2919240" cy="49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B4AC1F2-B06B-425B-972C-2E99C2024922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FA2A4B-D048-4EFE-96F0-18623B5E6AD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ED03E3-B816-4DF0-B7C7-7E291C52DF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E940DA-C74C-4C17-A9F1-1286A1C3226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1CE0CF-D614-4BBA-A543-7750C488DD4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3019CB-A2C3-4DBA-9BD9-3220C4FD297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7DCB21-BB29-43A7-81A0-708E706879E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B2A1DD-2968-4D90-B449-FE871F091C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548AD9-4115-41FF-B7FC-7DFA062000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A8CB0E-E49D-4665-9B92-59AF380376A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7BA9BB-C5FC-4827-AC7D-7DCAF2FDCE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257890-3FEF-41B4-832E-0DA5076AE0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C7689F-7F3D-4A24-8308-FFCBE4B2C4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EFF0BAF-E4AC-48B7-9E93-331414FE415B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テキスト ボックス 5"/>
          <p:cNvSpPr/>
          <p:nvPr/>
        </p:nvSpPr>
        <p:spPr>
          <a:xfrm>
            <a:off x="1453320" y="3124080"/>
            <a:ext cx="730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1 dp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テキスト ボックス 5"/>
          <p:cNvSpPr/>
          <p:nvPr/>
        </p:nvSpPr>
        <p:spPr>
          <a:xfrm>
            <a:off x="1453320" y="6095880"/>
            <a:ext cx="730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2 dp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テキスト ボックス 5"/>
          <p:cNvSpPr/>
          <p:nvPr/>
        </p:nvSpPr>
        <p:spPr>
          <a:xfrm>
            <a:off x="4425120" y="11160"/>
            <a:ext cx="730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3 dp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テキスト ボックス 5"/>
          <p:cNvSpPr/>
          <p:nvPr/>
        </p:nvSpPr>
        <p:spPr>
          <a:xfrm>
            <a:off x="4561560" y="3124080"/>
            <a:ext cx="730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4 dp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テキスト ボックス 5"/>
          <p:cNvSpPr/>
          <p:nvPr/>
        </p:nvSpPr>
        <p:spPr>
          <a:xfrm>
            <a:off x="4561560" y="6095880"/>
            <a:ext cx="730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5 dp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Picture 10" descr="C:\Documents and Settings\tetsuo\My Documents\2010\1002\100225\100225\100225-edit\C3-100225_33hpf_kaede_WildType_3-1.tif"/>
          <p:cNvPicPr/>
          <p:nvPr/>
        </p:nvPicPr>
        <p:blipFill>
          <a:blip r:embed="rId1"/>
          <a:stretch/>
        </p:blipFill>
        <p:spPr>
          <a:xfrm>
            <a:off x="685800" y="3524400"/>
            <a:ext cx="2341440" cy="234144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9" descr="C:\Documents and Settings\tetsuo\My Documents\2010\1002\100226\100226_55hpf\100226edit\Composite (RGB).tif"/>
          <p:cNvPicPr/>
          <p:nvPr/>
        </p:nvPicPr>
        <p:blipFill>
          <a:blip r:embed="rId2"/>
          <a:stretch/>
        </p:blipFill>
        <p:spPr>
          <a:xfrm>
            <a:off x="685800" y="6551640"/>
            <a:ext cx="2362320" cy="236232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10" descr="C:\Documents and Settings\tetsuo\My Documents\2010\1002\100227\100227_76hpf\100227_confocal\edit\100227_76hpf_kaede_WildType_4-3.tif"/>
          <p:cNvPicPr/>
          <p:nvPr/>
        </p:nvPicPr>
        <p:blipFill>
          <a:blip r:embed="rId3"/>
          <a:stretch/>
        </p:blipFill>
        <p:spPr>
          <a:xfrm>
            <a:off x="3657600" y="468360"/>
            <a:ext cx="2362320" cy="236232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12" descr="C:\Documents and Settings\tetsuo\My Documents\2010\1002\100228\100228_confocal\Wild Type\100228_108hpf_kaede_WT_1-4.tif"/>
          <p:cNvPicPr/>
          <p:nvPr/>
        </p:nvPicPr>
        <p:blipFill>
          <a:blip r:embed="rId4"/>
          <a:stretch/>
        </p:blipFill>
        <p:spPr>
          <a:xfrm>
            <a:off x="3657600" y="3525840"/>
            <a:ext cx="2362320" cy="236232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17" descr="C:\Documents and Settings\tetsuo\My Documents\2010\1003\100325\100325_confocal\edit\100325_123hpf_kaede_WT_3.tif"/>
          <p:cNvPicPr/>
          <p:nvPr/>
        </p:nvPicPr>
        <p:blipFill>
          <a:blip r:embed="rId5"/>
          <a:stretch/>
        </p:blipFill>
        <p:spPr>
          <a:xfrm>
            <a:off x="3657600" y="6553080"/>
            <a:ext cx="2362320" cy="236232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8" descr="C:\Documents and Settings\tetsuo\My Documents\2010\1003\100319\100319_15hpf_confocal\edit\C3-100319_15hpf_retina_1-1.tif"/>
          <p:cNvPicPr/>
          <p:nvPr/>
        </p:nvPicPr>
        <p:blipFill>
          <a:blip r:embed="rId6"/>
          <a:stretch/>
        </p:blipFill>
        <p:spPr>
          <a:xfrm>
            <a:off x="685800" y="457200"/>
            <a:ext cx="2362320" cy="2362320"/>
          </a:xfrm>
          <a:prstGeom prst="rect">
            <a:avLst/>
          </a:prstGeom>
          <a:ln w="0">
            <a:noFill/>
          </a:ln>
        </p:spPr>
      </p:pic>
      <p:sp>
        <p:nvSpPr>
          <p:cNvPr id="59" name="テキスト ボックス 5"/>
          <p:cNvSpPr/>
          <p:nvPr/>
        </p:nvSpPr>
        <p:spPr>
          <a:xfrm>
            <a:off x="1449360" y="11160"/>
            <a:ext cx="86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15 hp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直線コネクタ 16"/>
          <p:cNvSpPr/>
          <p:nvPr/>
        </p:nvSpPr>
        <p:spPr>
          <a:xfrm flipH="1" flipV="1">
            <a:off x="1599840" y="761760"/>
            <a:ext cx="304920" cy="685800"/>
          </a:xfrm>
          <a:prstGeom prst="line">
            <a:avLst/>
          </a:prstGeom>
          <a:ln w="12600">
            <a:solidFill>
              <a:srgbClr val="ffffff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テキスト ボックス 17"/>
          <p:cNvSpPr/>
          <p:nvPr/>
        </p:nvSpPr>
        <p:spPr>
          <a:xfrm>
            <a:off x="764280" y="457200"/>
            <a:ext cx="936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Arial"/>
              </a:rPr>
              <a:t>Optic cu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直線コネクタ 18"/>
          <p:cNvSpPr/>
          <p:nvPr/>
        </p:nvSpPr>
        <p:spPr>
          <a:xfrm flipH="1" flipV="1">
            <a:off x="1218960" y="3886200"/>
            <a:ext cx="609480" cy="990720"/>
          </a:xfrm>
          <a:prstGeom prst="line">
            <a:avLst/>
          </a:prstGeom>
          <a:ln w="12600">
            <a:solidFill>
              <a:srgbClr val="ffffff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テキスト ボックス 19"/>
          <p:cNvSpPr/>
          <p:nvPr/>
        </p:nvSpPr>
        <p:spPr>
          <a:xfrm>
            <a:off x="748800" y="3581280"/>
            <a:ext cx="1608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Arial"/>
              </a:rPr>
              <a:t>Primodium of len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テキスト ボックス 20"/>
          <p:cNvSpPr/>
          <p:nvPr/>
        </p:nvSpPr>
        <p:spPr>
          <a:xfrm>
            <a:off x="689760" y="6553080"/>
            <a:ext cx="1212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Arial"/>
              </a:rPr>
              <a:t>Ganglion cel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直線コネクタ 21"/>
          <p:cNvSpPr/>
          <p:nvPr/>
        </p:nvSpPr>
        <p:spPr>
          <a:xfrm flipH="1" flipV="1">
            <a:off x="1143000" y="6857640"/>
            <a:ext cx="380880" cy="685800"/>
          </a:xfrm>
          <a:prstGeom prst="line">
            <a:avLst/>
          </a:prstGeom>
          <a:ln w="12600">
            <a:solidFill>
              <a:srgbClr val="ffffff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テキスト ボックス 23"/>
          <p:cNvSpPr/>
          <p:nvPr/>
        </p:nvSpPr>
        <p:spPr>
          <a:xfrm>
            <a:off x="3657600" y="2511360"/>
            <a:ext cx="1523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Arial"/>
              </a:rPr>
              <a:t>Amacrine cel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直線コネクタ 24"/>
          <p:cNvSpPr/>
          <p:nvPr/>
        </p:nvSpPr>
        <p:spPr>
          <a:xfrm flipH="1">
            <a:off x="4038480" y="1905120"/>
            <a:ext cx="76320" cy="609480"/>
          </a:xfrm>
          <a:prstGeom prst="line">
            <a:avLst/>
          </a:prstGeom>
          <a:ln w="12600">
            <a:solidFill>
              <a:srgbClr val="ffffff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テキスト ボックス 28"/>
          <p:cNvSpPr/>
          <p:nvPr/>
        </p:nvSpPr>
        <p:spPr>
          <a:xfrm>
            <a:off x="3661560" y="457200"/>
            <a:ext cx="1212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Arial"/>
              </a:rPr>
              <a:t>Ganglion cel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直線コネクタ 29"/>
          <p:cNvSpPr/>
          <p:nvPr/>
        </p:nvSpPr>
        <p:spPr>
          <a:xfrm>
            <a:off x="4114080" y="838080"/>
            <a:ext cx="330120" cy="685800"/>
          </a:xfrm>
          <a:prstGeom prst="line">
            <a:avLst/>
          </a:prstGeom>
          <a:ln w="1260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clickEffect" fill="hold" presetClass="entr" presetID="5" presetSubtype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checkerboard(across)" transition="in">
                                      <p:cBhvr additive="repl">
                                        <p:cTn id="7" dur="500"/>
                                        <p:tgtEl>
                                          <p:spTgt spid="5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1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11T05:18:35Z</dcterms:created>
  <dc:creator>yuhei nishimura</dc:creator>
  <dc:description/>
  <dc:language>en-US</dc:language>
  <cp:lastModifiedBy>Coge</cp:lastModifiedBy>
  <dcterms:modified xsi:type="dcterms:W3CDTF">2010-09-14T05:05:11Z</dcterms:modified>
  <cp:revision>176</cp:revision>
  <dc:subject/>
  <dc:title>スライド 1</dc:title>
</cp:coreProperties>
</file>